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4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F7C80"/>
    <a:srgbClr val="FF3300"/>
    <a:srgbClr val="FF9999"/>
    <a:srgbClr val="00CC99"/>
    <a:srgbClr val="FFCCCC"/>
    <a:srgbClr val="FF00FF"/>
    <a:srgbClr val="00FF00"/>
    <a:srgbClr val="0066FF"/>
    <a:srgbClr val="00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72" autoAdjust="0"/>
    <p:restoredTop sz="96357" autoAdjust="0"/>
  </p:normalViewPr>
  <p:slideViewPr>
    <p:cSldViewPr snapToGrid="0">
      <p:cViewPr varScale="1">
        <p:scale>
          <a:sx n="65" d="100"/>
          <a:sy n="65" d="100"/>
        </p:scale>
        <p:origin x="3318" y="72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B67784-2E92-45D3-B067-63CA16A7AE5D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BC0731-8107-434F-BC23-650AAAC2B1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0186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3BC0731-8107-434F-BC23-650AAAC2B1F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07990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853B5-21F1-4759-BEC5-06AB9CFE5497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338A3-A634-41B9-BCAD-801CAA253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04734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853B5-21F1-4759-BEC5-06AB9CFE5497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338A3-A634-41B9-BCAD-801CAA253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48338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853B5-21F1-4759-BEC5-06AB9CFE5497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338A3-A634-41B9-BCAD-801CAA253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01914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853B5-21F1-4759-BEC5-06AB9CFE5497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338A3-A634-41B9-BCAD-801CAA253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2129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853B5-21F1-4759-BEC5-06AB9CFE5497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338A3-A634-41B9-BCAD-801CAA253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37944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853B5-21F1-4759-BEC5-06AB9CFE5497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338A3-A634-41B9-BCAD-801CAA253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75454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853B5-21F1-4759-BEC5-06AB9CFE5497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338A3-A634-41B9-BCAD-801CAA253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0596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853B5-21F1-4759-BEC5-06AB9CFE5497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338A3-A634-41B9-BCAD-801CAA253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96307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853B5-21F1-4759-BEC5-06AB9CFE5497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338A3-A634-41B9-BCAD-801CAA253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8123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853B5-21F1-4759-BEC5-06AB9CFE5497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338A3-A634-41B9-BCAD-801CAA253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08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853B5-21F1-4759-BEC5-06AB9CFE5497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338A3-A634-41B9-BCAD-801CAA253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8525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C853B5-21F1-4759-BEC5-06AB9CFE5497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F338A3-A634-41B9-BCAD-801CAA253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5342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09F8CE86-2427-64B1-EA45-0BC1BDF3B90E}"/>
              </a:ext>
            </a:extLst>
          </p:cNvPr>
          <p:cNvCxnSpPr/>
          <p:nvPr/>
        </p:nvCxnSpPr>
        <p:spPr>
          <a:xfrm>
            <a:off x="0" y="0"/>
            <a:ext cx="914400" cy="0"/>
          </a:xfrm>
          <a:prstGeom prst="line">
            <a:avLst/>
          </a:prstGeom>
          <a:ln w="0" cap="flat" cmpd="sng" algn="ctr">
            <a:solidFill>
              <a:srgbClr val="FBFFFF"/>
            </a:solidFill>
            <a:prstDash val="solid"/>
            <a:miter lim="800000"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rotWithShape="0">
                    <a:scrgbClr r="0" g="0" b="0"/>
                  </a:outerShdw>
                </a:effectLst>
              </a14:hiddenEffects>
            </a:ext>
          </a:ex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AC1041F3-A9EA-4659-FAFD-5106A933574A}"/>
              </a:ext>
            </a:extLst>
          </p:cNvPr>
          <p:cNvCxnSpPr/>
          <p:nvPr/>
        </p:nvCxnSpPr>
        <p:spPr>
          <a:xfrm>
            <a:off x="0" y="0"/>
            <a:ext cx="914400" cy="0"/>
          </a:xfrm>
          <a:prstGeom prst="line">
            <a:avLst/>
          </a:prstGeom>
          <a:ln w="0" cap="flat" cmpd="sng" algn="ctr">
            <a:solidFill>
              <a:srgbClr val="FBFFFF"/>
            </a:solidFill>
            <a:prstDash val="solid"/>
            <a:miter lim="800000"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rotWithShape="0">
                    <a:scrgbClr r="0" g="0" b="0"/>
                  </a:outerShdw>
                </a:effectLst>
              </a14:hiddenEffects>
            </a:ext>
          </a:ex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69E4E6EB-FCF2-11FB-D82B-A0A467884FD5}"/>
              </a:ext>
            </a:extLst>
          </p:cNvPr>
          <p:cNvCxnSpPr/>
          <p:nvPr/>
        </p:nvCxnSpPr>
        <p:spPr>
          <a:xfrm>
            <a:off x="0" y="0"/>
            <a:ext cx="914400" cy="0"/>
          </a:xfrm>
          <a:prstGeom prst="line">
            <a:avLst/>
          </a:prstGeom>
          <a:ln w="0" cap="flat" cmpd="sng" algn="ctr">
            <a:solidFill>
              <a:srgbClr val="FBFFFF"/>
            </a:solidFill>
            <a:prstDash val="solid"/>
            <a:miter lim="800000"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rotWithShape="0">
                    <a:scrgbClr r="0" g="0" b="0"/>
                  </a:outerShdw>
                </a:effectLst>
              </a14:hiddenEffects>
            </a:ext>
          </a:ex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" name="Straight Connector 1">
            <a:extLst>
              <a:ext uri="{FF2B5EF4-FFF2-40B4-BE49-F238E27FC236}">
                <a16:creationId xmlns:a16="http://schemas.microsoft.com/office/drawing/2014/main" id="{F381C792-7F41-F5B4-07E3-AF175165070C}"/>
              </a:ext>
            </a:extLst>
          </p:cNvPr>
          <p:cNvCxnSpPr/>
          <p:nvPr/>
        </p:nvCxnSpPr>
        <p:spPr>
          <a:xfrm>
            <a:off x="0" y="0"/>
            <a:ext cx="914400" cy="0"/>
          </a:xfrm>
          <a:prstGeom prst="line">
            <a:avLst/>
          </a:prstGeom>
          <a:ln w="0" cap="flat" cmpd="sng" algn="ctr">
            <a:solidFill>
              <a:srgbClr val="FBFFFF"/>
            </a:solidFill>
            <a:prstDash val="solid"/>
            <a:miter lim="800000"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rotWithShape="0">
                    <a:scrgbClr r="0" g="0" b="0"/>
                  </a:outerShdw>
                </a:effectLst>
              </a14:hiddenEffects>
            </a:ext>
          </a:ex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5EE286EC-A287-421A-BB45-E1600CE6C35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24179587"/>
              </p:ext>
            </p:extLst>
          </p:nvPr>
        </p:nvGraphicFramePr>
        <p:xfrm>
          <a:off x="105769" y="1274885"/>
          <a:ext cx="6646460" cy="9642230"/>
        </p:xfrm>
        <a:graphic>
          <a:graphicData uri="http://schemas.openxmlformats.org/drawingml/2006/table">
            <a:tbl>
              <a:tblPr/>
              <a:tblGrid>
                <a:gridCol w="1855552">
                  <a:extLst>
                    <a:ext uri="{9D8B030D-6E8A-4147-A177-3AD203B41FA5}">
                      <a16:colId xmlns:a16="http://schemas.microsoft.com/office/drawing/2014/main" val="3068278869"/>
                    </a:ext>
                  </a:extLst>
                </a:gridCol>
                <a:gridCol w="2719861">
                  <a:extLst>
                    <a:ext uri="{9D8B030D-6E8A-4147-A177-3AD203B41FA5}">
                      <a16:colId xmlns:a16="http://schemas.microsoft.com/office/drawing/2014/main" val="2047216234"/>
                    </a:ext>
                  </a:extLst>
                </a:gridCol>
                <a:gridCol w="1110155">
                  <a:extLst>
                    <a:ext uri="{9D8B030D-6E8A-4147-A177-3AD203B41FA5}">
                      <a16:colId xmlns:a16="http://schemas.microsoft.com/office/drawing/2014/main" val="4105054910"/>
                    </a:ext>
                  </a:extLst>
                </a:gridCol>
                <a:gridCol w="960892">
                  <a:extLst>
                    <a:ext uri="{9D8B030D-6E8A-4147-A177-3AD203B41FA5}">
                      <a16:colId xmlns:a16="http://schemas.microsoft.com/office/drawing/2014/main" val="2296960080"/>
                    </a:ext>
                  </a:extLst>
                </a:gridCol>
              </a:tblGrid>
              <a:tr h="290869">
                <a:tc>
                  <a:txBody>
                    <a:bodyPr/>
                    <a:lstStyle/>
                    <a:p>
                      <a:pPr algn="ctr"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i="0" u="none" strike="noStrike">
                          <a:solidFill>
                            <a:srgbClr val="333333"/>
                          </a:solidFill>
                          <a:effectLst/>
                          <a:latin typeface="Calibri" panose="020F0502020204030204" pitchFamily="34" charset="0"/>
                        </a:rPr>
                        <a:t>Characteristic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i="0" u="none" strike="noStrike">
                          <a:solidFill>
                            <a:srgbClr val="333333"/>
                          </a:solidFill>
                          <a:effectLst/>
                          <a:latin typeface="Calibri" panose="020F0502020204030204" pitchFamily="34" charset="0"/>
                        </a:rPr>
                        <a:t>Categories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i="0" u="none" strike="noStrike" dirty="0">
                          <a:solidFill>
                            <a:srgbClr val="333333"/>
                          </a:solidFill>
                          <a:effectLst/>
                          <a:latin typeface="Calibri" panose="020F0502020204030204" pitchFamily="34" charset="0"/>
                        </a:rPr>
                        <a:t>N (%)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i="0" u="none" strike="noStrike">
                          <a:solidFill>
                            <a:srgbClr val="333333"/>
                          </a:solidFill>
                          <a:effectLst/>
                          <a:latin typeface="Calibri" panose="020F0502020204030204" pitchFamily="34" charset="0"/>
                        </a:rPr>
                        <a:t>Total (%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3840500"/>
                  </a:ext>
                </a:extLst>
              </a:tr>
              <a:tr h="290869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ge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8 (37-91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4 (100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4 (100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5408432"/>
                  </a:ext>
                </a:extLst>
              </a:tr>
              <a:tr h="290869">
                <a:tc rowSpan="2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der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1288" marR="111288" marT="55644" marB="5564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emale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 (53.5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4 (100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1288" marR="111288" marT="55644" marB="5564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8456822"/>
                  </a:ext>
                </a:extLst>
              </a:tr>
              <a:tr h="29086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 (46.5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28748086"/>
                  </a:ext>
                </a:extLst>
              </a:tr>
              <a:tr h="290869">
                <a:tc rowSpan="4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ce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1288" marR="111288" marT="55644" marB="5564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ian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(2.1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4 (100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1288" marR="111288" marT="55644" marB="5564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8031520"/>
                  </a:ext>
                </a:extLst>
              </a:tr>
              <a:tr h="29086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ack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 (8.3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89712830"/>
                  </a:ext>
                </a:extLst>
              </a:tr>
              <a:tr h="29086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ther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 (11.1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97269420"/>
                  </a:ext>
                </a:extLst>
              </a:tr>
              <a:tr h="29086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hite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3 (78.5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34147943"/>
                  </a:ext>
                </a:extLst>
              </a:tr>
              <a:tr h="290869">
                <a:tc rowSpan="4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moking status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1288" marR="111288" marT="55644" marB="5564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rrent Smoker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 (29.2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4 (100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1288" marR="111288" marT="55644" marB="5564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3413423"/>
                  </a:ext>
                </a:extLst>
              </a:tr>
              <a:tr h="29086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rmer Smoker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 (53.5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58635349"/>
                  </a:ext>
                </a:extLst>
              </a:tr>
              <a:tr h="29086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ver Smoker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 (14.6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1615816"/>
                  </a:ext>
                </a:extLst>
              </a:tr>
              <a:tr h="29086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known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(2.8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08282499"/>
                  </a:ext>
                </a:extLst>
              </a:tr>
              <a:tr h="290869">
                <a:tc rowSpan="3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emotherapy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1288" marR="111288" marT="55644" marB="5564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7 (67.4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4 (100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1288" marR="111288" marT="55644" marB="5564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8891365"/>
                  </a:ext>
                </a:extLst>
              </a:tr>
              <a:tr h="29086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known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 (13.2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98356901"/>
                  </a:ext>
                </a:extLst>
              </a:tr>
              <a:tr h="29086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 (19.4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30637927"/>
                  </a:ext>
                </a:extLst>
              </a:tr>
              <a:tr h="313616">
                <a:tc rowSpan="2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mily cancer history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1288" marR="111288" marT="55644" marB="5564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6 (73.6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4 (100)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1288" marR="111288" marT="55644" marB="5564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16066796"/>
                  </a:ext>
                </a:extLst>
              </a:tr>
              <a:tr h="31361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 (26.4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50683752"/>
                  </a:ext>
                </a:extLst>
              </a:tr>
              <a:tr h="290869">
                <a:tc rowSpan="12"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tology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1288" marR="111288" marT="55644" marB="5564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enocarcinoma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 (57.6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12"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4 (100)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1288" marR="111288" marT="55644" marB="5564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2306875"/>
                  </a:ext>
                </a:extLst>
              </a:tr>
              <a:tr h="52317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enocarcinoma and Squamous Cell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0.7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47952930"/>
                  </a:ext>
                </a:extLst>
              </a:tr>
              <a:tr h="29086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enosquamous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 (3.5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9070144"/>
                  </a:ext>
                </a:extLst>
              </a:tr>
              <a:tr h="29086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ypical Carcinoid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0.7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94217131"/>
                  </a:ext>
                </a:extLst>
              </a:tr>
              <a:tr h="52317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onchoalveolar carcinoma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1.4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88634073"/>
                  </a:ext>
                </a:extLst>
              </a:tr>
              <a:tr h="29086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rcinoid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(2.8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99063395"/>
                  </a:ext>
                </a:extLst>
              </a:tr>
              <a:tr h="29086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rge Cell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 (3.5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19482534"/>
                  </a:ext>
                </a:extLst>
              </a:tr>
              <a:tr h="52317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rge Cell - Neuroendocrine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0.7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27352636"/>
                  </a:ext>
                </a:extLst>
              </a:tr>
              <a:tr h="29086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nsmall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ell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0.7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61437703"/>
                  </a:ext>
                </a:extLst>
              </a:tr>
              <a:tr h="52317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eomorphic carcinoma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0.7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73692859"/>
                  </a:ext>
                </a:extLst>
              </a:tr>
              <a:tr h="52317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orly differentiated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(2.1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4437980"/>
                  </a:ext>
                </a:extLst>
              </a:tr>
              <a:tr h="29086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quamous cell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 (25.7)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1592" marR="11592" marT="1159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92163941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CA770A70-FD67-4934-89BE-9D1EFA0DD594}"/>
              </a:ext>
            </a:extLst>
          </p:cNvPr>
          <p:cNvSpPr txBox="1"/>
          <p:nvPr/>
        </p:nvSpPr>
        <p:spPr>
          <a:xfrm>
            <a:off x="165434" y="848686"/>
            <a:ext cx="652713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Supplementary Table 1. Clinicopathological characteristics of NSCLC validation cohort (YTMA-250).</a:t>
            </a:r>
          </a:p>
        </p:txBody>
      </p:sp>
    </p:spTree>
    <p:extLst>
      <p:ext uri="{BB962C8B-B14F-4D97-AF65-F5344CB8AC3E}">
        <p14:creationId xmlns:p14="http://schemas.microsoft.com/office/powerpoint/2010/main" val="40392955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232</TotalTime>
  <Words>217</Words>
  <Application>Microsoft Office PowerPoint</Application>
  <PresentationFormat>Widescreen</PresentationFormat>
  <Paragraphs>7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Outline for LAIR1 and ligand interaction</dc:title>
  <dc:creator>Nwe Aung, Thazin</dc:creator>
  <cp:lastModifiedBy>Nwe Aung, Thazin</cp:lastModifiedBy>
  <cp:revision>433</cp:revision>
  <dcterms:created xsi:type="dcterms:W3CDTF">2021-06-29T17:55:40Z</dcterms:created>
  <dcterms:modified xsi:type="dcterms:W3CDTF">2023-02-15T18:49:12Z</dcterms:modified>
</cp:coreProperties>
</file>